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40538" cy="93599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5" d="100"/>
          <a:sy n="85" d="100"/>
        </p:scale>
        <p:origin x="29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aterial%20for%20the%20figures\Supplementary%20Table%20S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aterial%20for%20the%20figures\Supplementary%20Table%20S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aterial%20for%20the%20figures\Supplementary%20Table%20S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aterial%20for%20the%20figures\Supplementary%20Table%20S3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aterial%20for%20the%20figures\Supplementary%20Table%20S3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aterial%20for%20the%20figures\Supplementary%20Table%20S3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</a:rPr>
              <a:t>ibrFA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filled"/>
        <c:varyColors val="0"/>
        <c:ser>
          <c:idx val="0"/>
          <c:order val="0"/>
          <c:tx>
            <c:strRef>
              <c:f>Average!$I$65</c:f>
              <c:strCache>
                <c:ptCount val="1"/>
                <c:pt idx="0">
                  <c:v>N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J$64:$P$64</c:f>
              <c:strCache>
                <c:ptCount val="7"/>
                <c:pt idx="0">
                  <c:v>10Me-C12:0</c:v>
                </c:pt>
                <c:pt idx="1">
                  <c:v>11Me-C13:0</c:v>
                </c:pt>
                <c:pt idx="2">
                  <c:v>12Me-C14:0</c:v>
                </c:pt>
                <c:pt idx="3">
                  <c:v>13Me-C15:0</c:v>
                </c:pt>
                <c:pt idx="4">
                  <c:v>14Me-C16:0</c:v>
                </c:pt>
                <c:pt idx="5">
                  <c:v>15Me-C17:0</c:v>
                </c:pt>
                <c:pt idx="6">
                  <c:v>16Me-C18:0</c:v>
                </c:pt>
              </c:strCache>
            </c:strRef>
          </c:cat>
          <c:val>
            <c:numRef>
              <c:f>Average!$J$65:$P$65</c:f>
              <c:numCache>
                <c:formatCode>0.00</c:formatCode>
                <c:ptCount val="7"/>
                <c:pt idx="0">
                  <c:v>2.6966046360399905E-2</c:v>
                </c:pt>
                <c:pt idx="1">
                  <c:v>4.2507923339310638E-2</c:v>
                </c:pt>
                <c:pt idx="2">
                  <c:v>0.40954231278387465</c:v>
                </c:pt>
                <c:pt idx="3">
                  <c:v>0.79196351005896626</c:v>
                </c:pt>
                <c:pt idx="4">
                  <c:v>0.77150683748217508</c:v>
                </c:pt>
                <c:pt idx="5">
                  <c:v>0.2174039989215571</c:v>
                </c:pt>
                <c:pt idx="6">
                  <c:v>0.27290079074166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16-41E2-A97C-0671CD5C62D3}"/>
            </c:ext>
          </c:extLst>
        </c:ser>
        <c:ser>
          <c:idx val="1"/>
          <c:order val="1"/>
          <c:tx>
            <c:strRef>
              <c:f>Average!$I$66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rgbClr val="FF0000">
                <a:alpha val="40000"/>
              </a:srgbClr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J$64:$P$64</c:f>
              <c:strCache>
                <c:ptCount val="7"/>
                <c:pt idx="0">
                  <c:v>10Me-C12:0</c:v>
                </c:pt>
                <c:pt idx="1">
                  <c:v>11Me-C13:0</c:v>
                </c:pt>
                <c:pt idx="2">
                  <c:v>12Me-C14:0</c:v>
                </c:pt>
                <c:pt idx="3">
                  <c:v>13Me-C15:0</c:v>
                </c:pt>
                <c:pt idx="4">
                  <c:v>14Me-C16:0</c:v>
                </c:pt>
                <c:pt idx="5">
                  <c:v>15Me-C17:0</c:v>
                </c:pt>
                <c:pt idx="6">
                  <c:v>16Me-C18:0</c:v>
                </c:pt>
              </c:strCache>
            </c:strRef>
          </c:cat>
          <c:val>
            <c:numRef>
              <c:f>Average!$J$66:$P$66</c:f>
              <c:numCache>
                <c:formatCode>0.00</c:formatCode>
                <c:ptCount val="7"/>
                <c:pt idx="0">
                  <c:v>2.2297853047233768E-2</c:v>
                </c:pt>
                <c:pt idx="1">
                  <c:v>5.7753748047575236E-2</c:v>
                </c:pt>
                <c:pt idx="2">
                  <c:v>0.37265471226853197</c:v>
                </c:pt>
                <c:pt idx="3">
                  <c:v>1.1909994663227355</c:v>
                </c:pt>
                <c:pt idx="4">
                  <c:v>0.67574475212995333</c:v>
                </c:pt>
                <c:pt idx="5">
                  <c:v>0.31328713118399115</c:v>
                </c:pt>
                <c:pt idx="6">
                  <c:v>0.301780769234195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916-41E2-A97C-0671CD5C62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6296847"/>
        <c:axId val="686298511"/>
      </c:radarChart>
      <c:catAx>
        <c:axId val="6862968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86298511"/>
        <c:crosses val="autoZero"/>
        <c:auto val="1"/>
        <c:lblAlgn val="ctr"/>
        <c:lblOffset val="100"/>
        <c:noMultiLvlLbl val="0"/>
      </c:catAx>
      <c:valAx>
        <c:axId val="686298511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miter lim="800000"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862968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</a:rPr>
              <a:t>abrFA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filled"/>
        <c:varyColors val="0"/>
        <c:ser>
          <c:idx val="0"/>
          <c:order val="0"/>
          <c:tx>
            <c:strRef>
              <c:f>Average!$I$65</c:f>
              <c:strCache>
                <c:ptCount val="1"/>
                <c:pt idx="0">
                  <c:v>N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R$64:$X$64</c:f>
              <c:strCache>
                <c:ptCount val="7"/>
                <c:pt idx="0">
                  <c:v>9Me-C12:0</c:v>
                </c:pt>
                <c:pt idx="1">
                  <c:v>10Me-C13:0</c:v>
                </c:pt>
                <c:pt idx="2">
                  <c:v>11Me-C14:0</c:v>
                </c:pt>
                <c:pt idx="3">
                  <c:v>12Me-C15:0</c:v>
                </c:pt>
                <c:pt idx="4">
                  <c:v>13Me-C16:0</c:v>
                </c:pt>
                <c:pt idx="5">
                  <c:v>14Me-C17:0</c:v>
                </c:pt>
                <c:pt idx="6">
                  <c:v>15Me-C18:0</c:v>
                </c:pt>
              </c:strCache>
            </c:strRef>
          </c:cat>
          <c:val>
            <c:numRef>
              <c:f>Average!$R$65:$X$65</c:f>
              <c:numCache>
                <c:formatCode>0.00</c:formatCode>
                <c:ptCount val="7"/>
                <c:pt idx="0">
                  <c:v>1.1795899699250649E-2</c:v>
                </c:pt>
                <c:pt idx="1">
                  <c:v>9.0569701729110108E-2</c:v>
                </c:pt>
                <c:pt idx="2">
                  <c:v>7.3591858383076844E-2</c:v>
                </c:pt>
                <c:pt idx="3">
                  <c:v>1.0516513210834491</c:v>
                </c:pt>
                <c:pt idx="4">
                  <c:v>0.59670262933677509</c:v>
                </c:pt>
                <c:pt idx="5">
                  <c:v>0.53390821069100669</c:v>
                </c:pt>
                <c:pt idx="6">
                  <c:v>0.748784177667213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7A-4452-9788-8571F9EC1E3D}"/>
            </c:ext>
          </c:extLst>
        </c:ser>
        <c:ser>
          <c:idx val="1"/>
          <c:order val="1"/>
          <c:tx>
            <c:strRef>
              <c:f>Average!$I$66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rgbClr val="FF0000">
                <a:alpha val="40000"/>
              </a:srgbClr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R$64:$X$64</c:f>
              <c:strCache>
                <c:ptCount val="7"/>
                <c:pt idx="0">
                  <c:v>9Me-C12:0</c:v>
                </c:pt>
                <c:pt idx="1">
                  <c:v>10Me-C13:0</c:v>
                </c:pt>
                <c:pt idx="2">
                  <c:v>11Me-C14:0</c:v>
                </c:pt>
                <c:pt idx="3">
                  <c:v>12Me-C15:0</c:v>
                </c:pt>
                <c:pt idx="4">
                  <c:v>13Me-C16:0</c:v>
                </c:pt>
                <c:pt idx="5">
                  <c:v>14Me-C17:0</c:v>
                </c:pt>
                <c:pt idx="6">
                  <c:v>15Me-C18:0</c:v>
                </c:pt>
              </c:strCache>
            </c:strRef>
          </c:cat>
          <c:val>
            <c:numRef>
              <c:f>Average!$R$66:$X$66</c:f>
              <c:numCache>
                <c:formatCode>0.00</c:formatCode>
                <c:ptCount val="7"/>
                <c:pt idx="0">
                  <c:v>7.0835706524659727E-3</c:v>
                </c:pt>
                <c:pt idx="1">
                  <c:v>0.12623129719924517</c:v>
                </c:pt>
                <c:pt idx="2">
                  <c:v>4.1837952277319942E-2</c:v>
                </c:pt>
                <c:pt idx="3">
                  <c:v>1.586696116259031</c:v>
                </c:pt>
                <c:pt idx="4">
                  <c:v>0.96919614004569121</c:v>
                </c:pt>
                <c:pt idx="5">
                  <c:v>0.73939285817482159</c:v>
                </c:pt>
                <c:pt idx="6">
                  <c:v>1.50087194161278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27A-4452-9788-8571F9EC1E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5784303"/>
        <c:axId val="785779311"/>
      </c:radarChart>
      <c:catAx>
        <c:axId val="7857843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85779311"/>
        <c:crosses val="autoZero"/>
        <c:auto val="1"/>
        <c:lblAlgn val="ctr"/>
        <c:lblOffset val="100"/>
        <c:noMultiLvlLbl val="0"/>
      </c:catAx>
      <c:valAx>
        <c:axId val="78577931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miter lim="800000"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857843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</a:rPr>
              <a:t>eFA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filled"/>
        <c:varyColors val="0"/>
        <c:ser>
          <c:idx val="0"/>
          <c:order val="0"/>
          <c:tx>
            <c:strRef>
              <c:f>Average!$I$65</c:f>
              <c:strCache>
                <c:ptCount val="1"/>
                <c:pt idx="0">
                  <c:v>N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Z$64:$AG$64</c:f>
              <c:strCache>
                <c:ptCount val="8"/>
                <c:pt idx="0">
                  <c:v>C12:0</c:v>
                </c:pt>
                <c:pt idx="1">
                  <c:v>C14:0</c:v>
                </c:pt>
                <c:pt idx="2">
                  <c:v>C16:0</c:v>
                </c:pt>
                <c:pt idx="3">
                  <c:v>C18:0</c:v>
                </c:pt>
                <c:pt idx="4">
                  <c:v>C20:0</c:v>
                </c:pt>
                <c:pt idx="5">
                  <c:v>C22:0</c:v>
                </c:pt>
                <c:pt idx="6">
                  <c:v>C24:0</c:v>
                </c:pt>
                <c:pt idx="7">
                  <c:v>C26:0</c:v>
                </c:pt>
              </c:strCache>
            </c:strRef>
          </c:cat>
          <c:val>
            <c:numRef>
              <c:f>Average!$Z$65:$AG$65</c:f>
              <c:numCache>
                <c:formatCode>0.00</c:formatCode>
                <c:ptCount val="8"/>
                <c:pt idx="0">
                  <c:v>1.0784122530465583</c:v>
                </c:pt>
                <c:pt idx="1">
                  <c:v>6.6734957718546344</c:v>
                </c:pt>
                <c:pt idx="2">
                  <c:v>81.937359404297183</c:v>
                </c:pt>
                <c:pt idx="3">
                  <c:v>34.068161796662743</c:v>
                </c:pt>
                <c:pt idx="4">
                  <c:v>0.75583866687177925</c:v>
                </c:pt>
                <c:pt idx="5">
                  <c:v>0.82684706685212894</c:v>
                </c:pt>
                <c:pt idx="6">
                  <c:v>1.0754617896057979</c:v>
                </c:pt>
                <c:pt idx="7">
                  <c:v>0.155305349103176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8F-4696-9C27-B4C4A9B7840D}"/>
            </c:ext>
          </c:extLst>
        </c:ser>
        <c:ser>
          <c:idx val="1"/>
          <c:order val="1"/>
          <c:tx>
            <c:strRef>
              <c:f>Average!$I$66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rgbClr val="FF0000">
                <a:alpha val="40000"/>
              </a:srgbClr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Z$64:$AG$64</c:f>
              <c:strCache>
                <c:ptCount val="8"/>
                <c:pt idx="0">
                  <c:v>C12:0</c:v>
                </c:pt>
                <c:pt idx="1">
                  <c:v>C14:0</c:v>
                </c:pt>
                <c:pt idx="2">
                  <c:v>C16:0</c:v>
                </c:pt>
                <c:pt idx="3">
                  <c:v>C18:0</c:v>
                </c:pt>
                <c:pt idx="4">
                  <c:v>C20:0</c:v>
                </c:pt>
                <c:pt idx="5">
                  <c:v>C22:0</c:v>
                </c:pt>
                <c:pt idx="6">
                  <c:v>C24:0</c:v>
                </c:pt>
                <c:pt idx="7">
                  <c:v>C26:0</c:v>
                </c:pt>
              </c:strCache>
            </c:strRef>
          </c:cat>
          <c:val>
            <c:numRef>
              <c:f>Average!$Z$66:$AG$66</c:f>
              <c:numCache>
                <c:formatCode>0.00</c:formatCode>
                <c:ptCount val="8"/>
                <c:pt idx="0">
                  <c:v>1.1353615226181875</c:v>
                </c:pt>
                <c:pt idx="1">
                  <c:v>12.081352542833322</c:v>
                </c:pt>
                <c:pt idx="2">
                  <c:v>140.83770424152308</c:v>
                </c:pt>
                <c:pt idx="3">
                  <c:v>39.27426631309865</c:v>
                </c:pt>
                <c:pt idx="4">
                  <c:v>1.1039388829552501</c:v>
                </c:pt>
                <c:pt idx="5">
                  <c:v>1.0938769171022948</c:v>
                </c:pt>
                <c:pt idx="6">
                  <c:v>1.5774341951022077</c:v>
                </c:pt>
                <c:pt idx="7">
                  <c:v>0.235401887869810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08F-4696-9C27-B4C4A9B784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1097407"/>
        <c:axId val="691101151"/>
      </c:radarChart>
      <c:catAx>
        <c:axId val="6910974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91101151"/>
        <c:crosses val="autoZero"/>
        <c:auto val="1"/>
        <c:lblAlgn val="ctr"/>
        <c:lblOffset val="100"/>
        <c:noMultiLvlLbl val="0"/>
      </c:catAx>
      <c:valAx>
        <c:axId val="69110115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miter lim="800000"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910974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</a:rPr>
              <a:t>oFA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filled"/>
        <c:varyColors val="0"/>
        <c:ser>
          <c:idx val="0"/>
          <c:order val="0"/>
          <c:tx>
            <c:strRef>
              <c:f>Average!$I$65</c:f>
              <c:strCache>
                <c:ptCount val="1"/>
                <c:pt idx="0">
                  <c:v>N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AI$64:$AO$64</c:f>
              <c:strCache>
                <c:ptCount val="7"/>
                <c:pt idx="0">
                  <c:v>C13:0</c:v>
                </c:pt>
                <c:pt idx="1">
                  <c:v>C15:0</c:v>
                </c:pt>
                <c:pt idx="2">
                  <c:v>C17:0</c:v>
                </c:pt>
                <c:pt idx="3">
                  <c:v>C19:0</c:v>
                </c:pt>
                <c:pt idx="4">
                  <c:v>C21:0</c:v>
                </c:pt>
                <c:pt idx="5">
                  <c:v>C23:0</c:v>
                </c:pt>
                <c:pt idx="6">
                  <c:v>C25:0</c:v>
                </c:pt>
              </c:strCache>
            </c:strRef>
          </c:cat>
          <c:val>
            <c:numRef>
              <c:f>Average!$AI$65:$AO$65</c:f>
              <c:numCache>
                <c:formatCode>0.00</c:formatCode>
                <c:ptCount val="7"/>
                <c:pt idx="0">
                  <c:v>0.1565059407945037</c:v>
                </c:pt>
                <c:pt idx="1">
                  <c:v>4.6519596331088016</c:v>
                </c:pt>
                <c:pt idx="2">
                  <c:v>1.7415952492879876</c:v>
                </c:pt>
                <c:pt idx="3">
                  <c:v>0.31993615456423835</c:v>
                </c:pt>
                <c:pt idx="4">
                  <c:v>0.37653818720806476</c:v>
                </c:pt>
                <c:pt idx="5">
                  <c:v>0.36181510814652279</c:v>
                </c:pt>
                <c:pt idx="6">
                  <c:v>0.300673484821711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EC-4050-BB00-D9CE2C4ED577}"/>
            </c:ext>
          </c:extLst>
        </c:ser>
        <c:ser>
          <c:idx val="1"/>
          <c:order val="1"/>
          <c:tx>
            <c:strRef>
              <c:f>Average!$I$66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rgbClr val="FF0000">
                <a:alpha val="40000"/>
              </a:srgbClr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AI$64:$AO$64</c:f>
              <c:strCache>
                <c:ptCount val="7"/>
                <c:pt idx="0">
                  <c:v>C13:0</c:v>
                </c:pt>
                <c:pt idx="1">
                  <c:v>C15:0</c:v>
                </c:pt>
                <c:pt idx="2">
                  <c:v>C17:0</c:v>
                </c:pt>
                <c:pt idx="3">
                  <c:v>C19:0</c:v>
                </c:pt>
                <c:pt idx="4">
                  <c:v>C21:0</c:v>
                </c:pt>
                <c:pt idx="5">
                  <c:v>C23:0</c:v>
                </c:pt>
                <c:pt idx="6">
                  <c:v>C25:0</c:v>
                </c:pt>
              </c:strCache>
            </c:strRef>
          </c:cat>
          <c:val>
            <c:numRef>
              <c:f>Average!$AI$66:$AO$66</c:f>
              <c:numCache>
                <c:formatCode>0.00</c:formatCode>
                <c:ptCount val="7"/>
                <c:pt idx="0">
                  <c:v>0.24099889723676723</c:v>
                </c:pt>
                <c:pt idx="1">
                  <c:v>9.3514537696460831</c:v>
                </c:pt>
                <c:pt idx="2">
                  <c:v>3.0808570179894121</c:v>
                </c:pt>
                <c:pt idx="3">
                  <c:v>0.44783323619886667</c:v>
                </c:pt>
                <c:pt idx="4">
                  <c:v>0.44824829073627803</c:v>
                </c:pt>
                <c:pt idx="5">
                  <c:v>0.45970926952393104</c:v>
                </c:pt>
                <c:pt idx="6">
                  <c:v>0.350411252868789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AEC-4050-BB00-D9CE2C4ED5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1095743"/>
        <c:axId val="691098655"/>
      </c:radarChart>
      <c:catAx>
        <c:axId val="691095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91098655"/>
        <c:crosses val="autoZero"/>
        <c:auto val="1"/>
        <c:lblAlgn val="ctr"/>
        <c:lblOffset val="100"/>
        <c:noMultiLvlLbl val="0"/>
      </c:catAx>
      <c:valAx>
        <c:axId val="69109865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miter lim="800000"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91095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</a:rPr>
              <a:t>MUFAs, PUFA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filled"/>
        <c:varyColors val="0"/>
        <c:ser>
          <c:idx val="0"/>
          <c:order val="0"/>
          <c:tx>
            <c:strRef>
              <c:f>Average!$I$65</c:f>
              <c:strCache>
                <c:ptCount val="1"/>
                <c:pt idx="0">
                  <c:v>N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AQ$64:$AZ$64</c:f>
              <c:strCache>
                <c:ptCount val="10"/>
                <c:pt idx="0">
                  <c:v>C14:1</c:v>
                </c:pt>
                <c:pt idx="1">
                  <c:v>C16:1</c:v>
                </c:pt>
                <c:pt idx="2">
                  <c:v>C18:1</c:v>
                </c:pt>
                <c:pt idx="3">
                  <c:v>C20:1</c:v>
                </c:pt>
                <c:pt idx="4">
                  <c:v>C22:1</c:v>
                </c:pt>
                <c:pt idx="5">
                  <c:v>C24:1</c:v>
                </c:pt>
                <c:pt idx="6">
                  <c:v>C15:1</c:v>
                </c:pt>
                <c:pt idx="7">
                  <c:v>C17:1</c:v>
                </c:pt>
                <c:pt idx="8">
                  <c:v>C18:2</c:v>
                </c:pt>
                <c:pt idx="9">
                  <c:v>C20:2</c:v>
                </c:pt>
              </c:strCache>
            </c:strRef>
          </c:cat>
          <c:val>
            <c:numRef>
              <c:f>Average!$AQ$65:$AZ$65</c:f>
              <c:numCache>
                <c:formatCode>0.00</c:formatCode>
                <c:ptCount val="10"/>
                <c:pt idx="0">
                  <c:v>0.26491879121161888</c:v>
                </c:pt>
                <c:pt idx="1">
                  <c:v>6.5544545883162728</c:v>
                </c:pt>
                <c:pt idx="2">
                  <c:v>14.470479646109867</c:v>
                </c:pt>
                <c:pt idx="3">
                  <c:v>0.40804863776423778</c:v>
                </c:pt>
                <c:pt idx="4">
                  <c:v>7.0356614265102854E-2</c:v>
                </c:pt>
                <c:pt idx="5">
                  <c:v>0.11172727474979344</c:v>
                </c:pt>
                <c:pt idx="6">
                  <c:v>0.22043555113466815</c:v>
                </c:pt>
                <c:pt idx="7">
                  <c:v>0.85411563904754428</c:v>
                </c:pt>
                <c:pt idx="8">
                  <c:v>2.1768251160141863</c:v>
                </c:pt>
                <c:pt idx="9">
                  <c:v>0.345113540792747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E3-412A-A47F-42C1CCCC9F2E}"/>
            </c:ext>
          </c:extLst>
        </c:ser>
        <c:ser>
          <c:idx val="1"/>
          <c:order val="1"/>
          <c:tx>
            <c:strRef>
              <c:f>Average!$I$66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rgbClr val="FF0000">
                <a:alpha val="40000"/>
              </a:srgbClr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AQ$64:$AZ$64</c:f>
              <c:strCache>
                <c:ptCount val="10"/>
                <c:pt idx="0">
                  <c:v>C14:1</c:v>
                </c:pt>
                <c:pt idx="1">
                  <c:v>C16:1</c:v>
                </c:pt>
                <c:pt idx="2">
                  <c:v>C18:1</c:v>
                </c:pt>
                <c:pt idx="3">
                  <c:v>C20:1</c:v>
                </c:pt>
                <c:pt idx="4">
                  <c:v>C22:1</c:v>
                </c:pt>
                <c:pt idx="5">
                  <c:v>C24:1</c:v>
                </c:pt>
                <c:pt idx="6">
                  <c:v>C15:1</c:v>
                </c:pt>
                <c:pt idx="7">
                  <c:v>C17:1</c:v>
                </c:pt>
                <c:pt idx="8">
                  <c:v>C18:2</c:v>
                </c:pt>
                <c:pt idx="9">
                  <c:v>C20:2</c:v>
                </c:pt>
              </c:strCache>
            </c:strRef>
          </c:cat>
          <c:val>
            <c:numRef>
              <c:f>Average!$AQ$66:$AZ$66</c:f>
              <c:numCache>
                <c:formatCode>0.00</c:formatCode>
                <c:ptCount val="10"/>
                <c:pt idx="0">
                  <c:v>0.43223404556863548</c:v>
                </c:pt>
                <c:pt idx="1">
                  <c:v>13.204227997118247</c:v>
                </c:pt>
                <c:pt idx="2">
                  <c:v>26.10932138924754</c:v>
                </c:pt>
                <c:pt idx="3">
                  <c:v>0.59754778792917274</c:v>
                </c:pt>
                <c:pt idx="4">
                  <c:v>9.6047952380566765E-2</c:v>
                </c:pt>
                <c:pt idx="5">
                  <c:v>0.16196744822230874</c:v>
                </c:pt>
                <c:pt idx="6">
                  <c:v>0.42297308670744788</c:v>
                </c:pt>
                <c:pt idx="7">
                  <c:v>1.7070858575868009</c:v>
                </c:pt>
                <c:pt idx="8">
                  <c:v>2.7248940075056267</c:v>
                </c:pt>
                <c:pt idx="9">
                  <c:v>0.369199576393042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BE3-412A-A47F-42C1CCCC9F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5778063"/>
        <c:axId val="785780559"/>
      </c:radarChart>
      <c:catAx>
        <c:axId val="7857780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85780559"/>
        <c:crosses val="autoZero"/>
        <c:auto val="1"/>
        <c:lblAlgn val="ctr"/>
        <c:lblOffset val="100"/>
        <c:noMultiLvlLbl val="0"/>
      </c:catAx>
      <c:valAx>
        <c:axId val="78578055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miter lim="800000"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857780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chemeClr val="tx1"/>
                </a:solidFill>
              </a:rPr>
              <a:t>FOH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filled"/>
        <c:varyColors val="0"/>
        <c:ser>
          <c:idx val="0"/>
          <c:order val="0"/>
          <c:tx>
            <c:strRef>
              <c:f>Average!$I$65</c:f>
              <c:strCache>
                <c:ptCount val="1"/>
                <c:pt idx="0">
                  <c:v>N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BB$64:$BH$64</c:f>
              <c:strCache>
                <c:ptCount val="7"/>
                <c:pt idx="0">
                  <c:v>FOH14:0</c:v>
                </c:pt>
                <c:pt idx="1">
                  <c:v>FOH16:0</c:v>
                </c:pt>
                <c:pt idx="2">
                  <c:v>FOH18:0</c:v>
                </c:pt>
                <c:pt idx="3">
                  <c:v>FOH20:0</c:v>
                </c:pt>
                <c:pt idx="4">
                  <c:v>FOHC22:0</c:v>
                </c:pt>
                <c:pt idx="5">
                  <c:v>FOHC24:0</c:v>
                </c:pt>
                <c:pt idx="6">
                  <c:v>FOHC26:0</c:v>
                </c:pt>
              </c:strCache>
            </c:strRef>
          </c:cat>
          <c:val>
            <c:numRef>
              <c:f>Average!$BB$65:$BH$65</c:f>
              <c:numCache>
                <c:formatCode>0.00</c:formatCode>
                <c:ptCount val="7"/>
                <c:pt idx="0">
                  <c:v>0.2075110551729783</c:v>
                </c:pt>
                <c:pt idx="1">
                  <c:v>4.8117005691769501</c:v>
                </c:pt>
                <c:pt idx="2">
                  <c:v>34.292882355218985</c:v>
                </c:pt>
                <c:pt idx="3">
                  <c:v>2.162745064376367</c:v>
                </c:pt>
                <c:pt idx="4">
                  <c:v>2.2925068678307357</c:v>
                </c:pt>
                <c:pt idx="5">
                  <c:v>0.85702779571752596</c:v>
                </c:pt>
                <c:pt idx="6">
                  <c:v>0.405622587215876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E8-4173-AF03-90CD68A4895B}"/>
            </c:ext>
          </c:extLst>
        </c:ser>
        <c:ser>
          <c:idx val="1"/>
          <c:order val="1"/>
          <c:tx>
            <c:strRef>
              <c:f>Average!$I$66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rgbClr val="FF0000">
                <a:alpha val="40000"/>
              </a:srgbClr>
            </a:solidFill>
            <a:ln>
              <a:solidFill>
                <a:schemeClr val="tx1"/>
              </a:solidFill>
            </a:ln>
            <a:effectLst/>
          </c:spPr>
          <c:cat>
            <c:strRef>
              <c:f>Average!$BB$64:$BH$64</c:f>
              <c:strCache>
                <c:ptCount val="7"/>
                <c:pt idx="0">
                  <c:v>FOH14:0</c:v>
                </c:pt>
                <c:pt idx="1">
                  <c:v>FOH16:0</c:v>
                </c:pt>
                <c:pt idx="2">
                  <c:v>FOH18:0</c:v>
                </c:pt>
                <c:pt idx="3">
                  <c:v>FOH20:0</c:v>
                </c:pt>
                <c:pt idx="4">
                  <c:v>FOHC22:0</c:v>
                </c:pt>
                <c:pt idx="5">
                  <c:v>FOHC24:0</c:v>
                </c:pt>
                <c:pt idx="6">
                  <c:v>FOHC26:0</c:v>
                </c:pt>
              </c:strCache>
            </c:strRef>
          </c:cat>
          <c:val>
            <c:numRef>
              <c:f>Average!$BB$66:$BH$66</c:f>
              <c:numCache>
                <c:formatCode>0.00</c:formatCode>
                <c:ptCount val="7"/>
                <c:pt idx="0">
                  <c:v>0.25704374630184512</c:v>
                </c:pt>
                <c:pt idx="1">
                  <c:v>11.491807873219516</c:v>
                </c:pt>
                <c:pt idx="2">
                  <c:v>25.732211633088934</c:v>
                </c:pt>
                <c:pt idx="3">
                  <c:v>2.4415189724267297</c:v>
                </c:pt>
                <c:pt idx="4">
                  <c:v>2.5128756407151629</c:v>
                </c:pt>
                <c:pt idx="5">
                  <c:v>0.98083819960675567</c:v>
                </c:pt>
                <c:pt idx="6">
                  <c:v>0.44486989911899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E8-4173-AF03-90CD68A489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3481951"/>
        <c:axId val="783480703"/>
      </c:radarChart>
      <c:catAx>
        <c:axId val="7834819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83480703"/>
        <c:crosses val="autoZero"/>
        <c:auto val="1"/>
        <c:lblAlgn val="ctr"/>
        <c:lblOffset val="100"/>
        <c:noMultiLvlLbl val="0"/>
      </c:catAx>
      <c:valAx>
        <c:axId val="783480703"/>
        <c:scaling>
          <c:orientation val="minMax"/>
          <c:max val="3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miter lim="800000"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83481951"/>
        <c:crosses val="autoZero"/>
        <c:crossBetween val="between"/>
        <c:majorUnit val="6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531818"/>
            <a:ext cx="5814457" cy="3258632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916115"/>
            <a:ext cx="5130404" cy="2259809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849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631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98328"/>
            <a:ext cx="1474991" cy="7932083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98328"/>
            <a:ext cx="4339466" cy="7932083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016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686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333478"/>
            <a:ext cx="5899964" cy="3893458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263769"/>
            <a:ext cx="5899964" cy="2047477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576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491640"/>
            <a:ext cx="2907229" cy="5938771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491640"/>
            <a:ext cx="2907229" cy="5938771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696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98330"/>
            <a:ext cx="5899964" cy="1809148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294476"/>
            <a:ext cx="2893868" cy="112448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418964"/>
            <a:ext cx="2893868" cy="5028780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294476"/>
            <a:ext cx="2908120" cy="112448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418964"/>
            <a:ext cx="2908120" cy="5028780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445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344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599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23993"/>
            <a:ext cx="2206252" cy="2183977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347654"/>
            <a:ext cx="3463022" cy="6651596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807970"/>
            <a:ext cx="2206252" cy="5202112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066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23993"/>
            <a:ext cx="2206252" cy="2183977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347654"/>
            <a:ext cx="3463022" cy="6651596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807970"/>
            <a:ext cx="2206252" cy="5202112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337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98330"/>
            <a:ext cx="5899964" cy="1809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491640"/>
            <a:ext cx="5899964" cy="59387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675243"/>
            <a:ext cx="1539121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675243"/>
            <a:ext cx="2308682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675243"/>
            <a:ext cx="1539121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329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2364162" y="8825599"/>
            <a:ext cx="2518236" cy="3683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95" dirty="0"/>
              <a:t>Supplementary Figure </a:t>
            </a:r>
            <a:r>
              <a:rPr lang="en-US" sz="1795" dirty="0" smtClean="0"/>
              <a:t>S2</a:t>
            </a:r>
            <a:endParaRPr lang="en-US" sz="1795" dirty="0"/>
          </a:p>
        </p:txBody>
      </p:sp>
      <p:graphicFrame>
        <p:nvGraphicFramePr>
          <p:cNvPr id="9" name="Grafico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6012091"/>
              </p:ext>
            </p:extLst>
          </p:nvPr>
        </p:nvGraphicFramePr>
        <p:xfrm>
          <a:off x="1" y="301906"/>
          <a:ext cx="3509350" cy="2533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Grafico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6771704"/>
              </p:ext>
            </p:extLst>
          </p:nvPr>
        </p:nvGraphicFramePr>
        <p:xfrm>
          <a:off x="3331188" y="292404"/>
          <a:ext cx="3509350" cy="2533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Grafico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8436489"/>
              </p:ext>
            </p:extLst>
          </p:nvPr>
        </p:nvGraphicFramePr>
        <p:xfrm>
          <a:off x="1" y="3258438"/>
          <a:ext cx="3509350" cy="2533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Grafico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774092"/>
              </p:ext>
            </p:extLst>
          </p:nvPr>
        </p:nvGraphicFramePr>
        <p:xfrm>
          <a:off x="3350190" y="3258438"/>
          <a:ext cx="3509350" cy="2533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Grafico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123941"/>
              </p:ext>
            </p:extLst>
          </p:nvPr>
        </p:nvGraphicFramePr>
        <p:xfrm>
          <a:off x="14253" y="6214971"/>
          <a:ext cx="3509350" cy="2533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Grafico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5902216"/>
              </p:ext>
            </p:extLst>
          </p:nvPr>
        </p:nvGraphicFramePr>
        <p:xfrm>
          <a:off x="3095720" y="6224469"/>
          <a:ext cx="3768571" cy="25244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" name="Rettangolo 1"/>
          <p:cNvSpPr/>
          <p:nvPr/>
        </p:nvSpPr>
        <p:spPr>
          <a:xfrm>
            <a:off x="134411" y="215600"/>
            <a:ext cx="153612" cy="163212"/>
          </a:xfrm>
          <a:prstGeom prst="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795"/>
          </a:p>
        </p:txBody>
      </p:sp>
      <p:sp>
        <p:nvSpPr>
          <p:cNvPr id="16" name="Rettangolo 15"/>
          <p:cNvSpPr/>
          <p:nvPr/>
        </p:nvSpPr>
        <p:spPr>
          <a:xfrm>
            <a:off x="134411" y="465118"/>
            <a:ext cx="153612" cy="163212"/>
          </a:xfrm>
          <a:prstGeom prst="rect">
            <a:avLst/>
          </a:prstGeom>
          <a:solidFill>
            <a:srgbClr val="FF0000">
              <a:alpha val="60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795"/>
          </a:p>
        </p:txBody>
      </p:sp>
      <p:sp>
        <p:nvSpPr>
          <p:cNvPr id="3" name="CasellaDiTesto 2"/>
          <p:cNvSpPr txBox="1"/>
          <p:nvPr/>
        </p:nvSpPr>
        <p:spPr>
          <a:xfrm>
            <a:off x="288023" y="161021"/>
            <a:ext cx="388857" cy="2609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97" b="1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lang="en-US" sz="109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288023" y="416251"/>
            <a:ext cx="286527" cy="2609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97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9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0030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5</TotalTime>
  <Words>13</Words>
  <Application>Microsoft Office PowerPoint</Application>
  <PresentationFormat>Personalizzato</PresentationFormat>
  <Paragraphs>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MERA EMANUELA</dc:creator>
  <cp:lastModifiedBy>CAMERA EMANUELA</cp:lastModifiedBy>
  <cp:revision>17</cp:revision>
  <cp:lastPrinted>2020-11-26T13:53:04Z</cp:lastPrinted>
  <dcterms:created xsi:type="dcterms:W3CDTF">2020-11-26T13:51:09Z</dcterms:created>
  <dcterms:modified xsi:type="dcterms:W3CDTF">2021-08-02T13:22:44Z</dcterms:modified>
</cp:coreProperties>
</file>